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ggert" initials="E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91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5632" autoAdjust="0"/>
  </p:normalViewPr>
  <p:slideViewPr>
    <p:cSldViewPr snapToGrid="0">
      <p:cViewPr varScale="1">
        <p:scale>
          <a:sx n="143" d="100"/>
          <a:sy n="143" d="100"/>
        </p:scale>
        <p:origin x="-136" y="-15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4580059-13D1-4949-A783-5B2E7A1197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C800E190-6EE4-46CB-AA2E-40ECE55CF2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507F361-771B-4234-B015-B3F27750B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CC31B9A-3E3E-409D-AB00-59925BBB7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FD7216A-003D-4C79-9803-4B3C2BE22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201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B863C8B-B561-4D48-B73E-871A879D87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5EA0F84-F548-48A9-BD5D-13304A1647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9ADB15F-502E-4C2E-882E-5D56AA9C9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9F17B92-DA4A-41F3-A34B-C881E99D2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35C4B88-6761-4CF9-B2D2-A6878CDAE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57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AD74CD0-1B57-4DE3-9F97-3570E54760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5A377C9-0A24-4034-A833-CBF689BEF7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35174EF-0672-428A-8F57-25AED91D6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BEDF03B-CA59-497B-95B8-CF1A13A39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53EDBD0-094F-4DD5-BB67-2820BC7DA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706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29BBEA3-9562-46CF-AE4E-6E7792A4E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FA5F17E-3746-4D35-9D5A-21AECC146F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4FDEEE8-CF67-47B3-8BFD-34F449175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2E0C760-C35B-4766-902F-F089672C0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8F419C2-4E03-4A76-92F8-3D81AC9AD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448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DC8CB8A-C76E-48E7-85B9-1C89A8C32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6E6B878-61F9-422D-8DAE-7F43EA8D0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41BF4C2-055D-4E11-A40A-3922702B9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CC31A95-8D9D-40C5-A0FD-6E164FBD8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6149FDD-053B-4B4E-A040-7620D67BA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58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C5FE401-19C4-44A7-8080-1A7B66D54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8BF0467-6A16-4D0B-9A5C-850D680292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272DA5F-3240-4463-89BB-85230AFD27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63CA70F-E1DE-4373-8117-3E9593822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5267CF4-2BDE-4D6C-83A2-EFE3DDC4F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25B9CD7-41CE-4C47-A520-7FFACC1DC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329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3FD3305-9DF6-46E1-B0EC-0FC6166AF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BD8C4CF-9094-405D-B095-7671C8DF86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CC4E35F-CB47-49B5-BEA2-CF19385247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9BEF85F4-1F10-4EA8-A0CD-4609EBB3A7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A87CCF6-A896-4C7D-810C-FACFBB88F8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FC301CC-63F8-4127-83B4-EB9500377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31BD1854-EFF2-4D95-B3BE-2260EDAF3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B542FB2-B136-489C-AE28-65B334767E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554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5F626AF-1C40-40BB-94D1-C77F1992C2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E7C379BB-F179-4700-A0A0-38F1CC07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E6AA407-A569-4EBA-B42E-3C96598B9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BFFDD5A-4047-49F1-8E92-1FB17F537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967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A49EA33-11AF-4DB5-8B58-C0CCFE49E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4BFAB63-44AE-4CD2-8D6B-1BC194FC5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14F4F614-3D35-4E20-807E-AEB950EBC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82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6C2C643-3FB3-4D8C-A2E0-DD2A7A238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CC4B7EB-02CB-4008-A92A-2E6D78396D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F17B898-A061-4EFF-A759-27D48FDCC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9F65AAC-2178-4129-B486-52F20C3E0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F8082D7-3612-4826-A473-20F13D3BD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AE2F1F5-8C59-4789-9EED-9E1289C2A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94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7750FD6-8AC0-488E-8D00-9E7E90B7B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733A962A-B628-4DA1-8A2D-A45DD54616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DBA46F2-C59D-446A-BD6A-59370E8402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3CA8D0E-FF77-4F2F-8F8C-C0D93C606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6C04D1E-5BB0-433F-AAC6-39F51CB5A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5DD8A71-E9FA-4FDB-9773-7F71A95D5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17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0370B247-4674-432D-88C2-5A3660C43C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9C5E7CE-4EF7-44E0-A9B3-22B9015068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CE2C4D1-3808-4709-80F5-563CFE0658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CE6D1-0CB1-4A5F-A5B2-4DFB8BC1514C}" type="datetimeFigureOut">
              <a:rPr lang="en-US" smtClean="0"/>
              <a:t>30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F498604-AE27-48B7-9D98-8F3963DC7F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F3D4FB7-B5A9-4251-ADDD-C35B72C96B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B4656-EE71-4416-B123-7A8A2F7F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113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A2D7128-02DB-4CC3-B438-909D6ED8F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7056" y="1062085"/>
            <a:ext cx="10515600" cy="1325563"/>
          </a:xfrm>
        </p:spPr>
        <p:txBody>
          <a:bodyPr/>
          <a:lstStyle/>
          <a:p>
            <a:r>
              <a:rPr lang="en-US" dirty="0">
                <a:latin typeface="Arial"/>
                <a:cs typeface="Arial"/>
              </a:rPr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16B2A203-CA27-4DCB-9775-C843C23DF4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29" y="820490"/>
            <a:ext cx="12192000" cy="5613412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29DE7841-A158-4CE1-BCF9-AA2FCCF5ABA1}"/>
              </a:ext>
            </a:extLst>
          </p:cNvPr>
          <p:cNvSpPr/>
          <p:nvPr/>
        </p:nvSpPr>
        <p:spPr>
          <a:xfrm>
            <a:off x="6166455" y="820490"/>
            <a:ext cx="170046" cy="5247273"/>
          </a:xfrm>
          <a:prstGeom prst="rect">
            <a:avLst/>
          </a:prstGeom>
          <a:solidFill>
            <a:srgbClr val="FF00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/>
              <a:cs typeface="Arial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1C587814-E377-4165-9E7B-E20094009E3C}"/>
              </a:ext>
            </a:extLst>
          </p:cNvPr>
          <p:cNvSpPr txBox="1"/>
          <p:nvPr/>
        </p:nvSpPr>
        <p:spPr>
          <a:xfrm>
            <a:off x="4211676" y="1022686"/>
            <a:ext cx="2410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Impurity from the solvents or HPLC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74EC3675-DE86-401E-94B8-937419481AEB}"/>
              </a:ext>
            </a:extLst>
          </p:cNvPr>
          <p:cNvSpPr/>
          <p:nvPr/>
        </p:nvSpPr>
        <p:spPr>
          <a:xfrm>
            <a:off x="7553452" y="827064"/>
            <a:ext cx="202630" cy="5255991"/>
          </a:xfrm>
          <a:prstGeom prst="rect">
            <a:avLst/>
          </a:prstGeom>
          <a:solidFill>
            <a:schemeClr val="accent6">
              <a:lumMod val="60000"/>
              <a:lumOff val="40000"/>
              <a:alpha val="2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/>
              <a:cs typeface="Arial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170A8539-44EE-4BDF-A7A5-2E70B8C0553B}"/>
              </a:ext>
            </a:extLst>
          </p:cNvPr>
          <p:cNvSpPr txBox="1"/>
          <p:nvPr/>
        </p:nvSpPr>
        <p:spPr>
          <a:xfrm>
            <a:off x="8598367" y="4328729"/>
            <a:ext cx="241064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Main peak from INTERFERin  601.65 m/z which could be observed in other samples due to the cross contamination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B28EA8A7-E064-46AF-8DF3-29A8351DCD78}"/>
              </a:ext>
            </a:extLst>
          </p:cNvPr>
          <p:cNvSpPr/>
          <p:nvPr/>
        </p:nvSpPr>
        <p:spPr>
          <a:xfrm>
            <a:off x="6749732" y="820490"/>
            <a:ext cx="170046" cy="5247273"/>
          </a:xfrm>
          <a:prstGeom prst="rect">
            <a:avLst/>
          </a:prstGeom>
          <a:solidFill>
            <a:srgbClr val="FF00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/>
              <a:cs typeface="Arial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CA22E9C-51AF-4EFF-A11A-A18D9E0ADDD3}"/>
              </a:ext>
            </a:extLst>
          </p:cNvPr>
          <p:cNvSpPr txBox="1"/>
          <p:nvPr/>
        </p:nvSpPr>
        <p:spPr>
          <a:xfrm>
            <a:off x="527480" y="868410"/>
            <a:ext cx="339837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Loading buffer               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C969F4C8-239D-46E1-B6F1-345D8AEB97FE}"/>
              </a:ext>
            </a:extLst>
          </p:cNvPr>
          <p:cNvSpPr txBox="1"/>
          <p:nvPr/>
        </p:nvSpPr>
        <p:spPr>
          <a:xfrm>
            <a:off x="527480" y="2629243"/>
            <a:ext cx="387667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Loading buffer + </a:t>
            </a:r>
            <a:r>
              <a:rPr lang="en-US" dirty="0" err="1">
                <a:latin typeface="Arial"/>
                <a:cs typeface="Arial"/>
              </a:rPr>
              <a:t>DharmaFECT</a:t>
            </a:r>
            <a:r>
              <a:rPr lang="en-US" dirty="0">
                <a:latin typeface="Arial"/>
                <a:cs typeface="Arial"/>
              </a:rPr>
              <a:t>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030A5D50-CBD2-45C3-8F6B-D8BCA4FA7388}"/>
              </a:ext>
            </a:extLst>
          </p:cNvPr>
          <p:cNvSpPr txBox="1"/>
          <p:nvPr/>
        </p:nvSpPr>
        <p:spPr>
          <a:xfrm>
            <a:off x="527568" y="4405638"/>
            <a:ext cx="414328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Loading buffer + INTERFERin 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xmlns="" id="{0D6DCB79-B76B-44EF-8282-706F0BFCD7B3}"/>
              </a:ext>
            </a:extLst>
          </p:cNvPr>
          <p:cNvCxnSpPr/>
          <p:nvPr/>
        </p:nvCxnSpPr>
        <p:spPr>
          <a:xfrm flipH="1">
            <a:off x="7858556" y="4659360"/>
            <a:ext cx="558800" cy="2413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509290" y="185849"/>
            <a:ext cx="1929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. Positive mod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45FA9955-821C-4DD2-8C3F-C1D725D003B6}"/>
              </a:ext>
            </a:extLst>
          </p:cNvPr>
          <p:cNvSpPr txBox="1"/>
          <p:nvPr/>
        </p:nvSpPr>
        <p:spPr>
          <a:xfrm rot="16200000">
            <a:off x="-870456" y="2953430"/>
            <a:ext cx="2026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 Ion Coun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BBCA44C-7AA5-49C8-A777-CAF3A3D2BC30}"/>
              </a:ext>
            </a:extLst>
          </p:cNvPr>
          <p:cNvSpPr txBox="1"/>
          <p:nvPr/>
        </p:nvSpPr>
        <p:spPr>
          <a:xfrm rot="16200000">
            <a:off x="-861972" y="4769855"/>
            <a:ext cx="2026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 Ion Count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6DDDE6AA-D7F5-4875-A3A6-021E3891F580}"/>
              </a:ext>
            </a:extLst>
          </p:cNvPr>
          <p:cNvSpPr txBox="1"/>
          <p:nvPr/>
        </p:nvSpPr>
        <p:spPr>
          <a:xfrm rot="16200000">
            <a:off x="-858353" y="1209889"/>
            <a:ext cx="2026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 Ion Counts</a:t>
            </a:r>
          </a:p>
        </p:txBody>
      </p:sp>
    </p:spTree>
    <p:extLst>
      <p:ext uri="{BB962C8B-B14F-4D97-AF65-F5344CB8AC3E}">
        <p14:creationId xmlns:p14="http://schemas.microsoft.com/office/powerpoint/2010/main" val="471892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1C3882B-1F45-4E6F-B547-A575CDD7E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006" y="962025"/>
            <a:ext cx="10515600" cy="1325563"/>
          </a:xfrm>
        </p:spPr>
        <p:txBody>
          <a:bodyPr/>
          <a:lstStyle/>
          <a:p>
            <a:endParaRPr lang="en-US">
              <a:latin typeface="Arial"/>
              <a:cs typeface="Arial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5C60241E-D438-483E-B6FE-126FA94B3C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3" y="778955"/>
            <a:ext cx="12192000" cy="5613412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F31385FF-D759-48BE-8685-BA887DA73348}"/>
              </a:ext>
            </a:extLst>
          </p:cNvPr>
          <p:cNvSpPr/>
          <p:nvPr/>
        </p:nvSpPr>
        <p:spPr>
          <a:xfrm>
            <a:off x="6800111" y="812574"/>
            <a:ext cx="170046" cy="5247273"/>
          </a:xfrm>
          <a:prstGeom prst="rect">
            <a:avLst/>
          </a:prstGeom>
          <a:solidFill>
            <a:srgbClr val="FF00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/>
              <a:cs typeface="Arial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41B86662-F93D-42D8-81A3-317C3AB68A75}"/>
              </a:ext>
            </a:extLst>
          </p:cNvPr>
          <p:cNvSpPr/>
          <p:nvPr/>
        </p:nvSpPr>
        <p:spPr>
          <a:xfrm>
            <a:off x="7107004" y="778955"/>
            <a:ext cx="170046" cy="5247273"/>
          </a:xfrm>
          <a:prstGeom prst="rect">
            <a:avLst/>
          </a:prstGeom>
          <a:solidFill>
            <a:srgbClr val="FF00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/>
              <a:cs typeface="Arial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F46B41F-5764-49C7-AA87-D7B83F7F0BB7}"/>
              </a:ext>
            </a:extLst>
          </p:cNvPr>
          <p:cNvSpPr txBox="1"/>
          <p:nvPr/>
        </p:nvSpPr>
        <p:spPr>
          <a:xfrm>
            <a:off x="7648700" y="847170"/>
            <a:ext cx="2410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Impurity from the solvents or HPLC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E339369-8DA1-4B60-84FB-C3DABDB67447}"/>
              </a:ext>
            </a:extLst>
          </p:cNvPr>
          <p:cNvSpPr txBox="1"/>
          <p:nvPr/>
        </p:nvSpPr>
        <p:spPr>
          <a:xfrm>
            <a:off x="539130" y="793750"/>
            <a:ext cx="339837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Loading buffer              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518B17E9-7DD1-4E52-A238-36186155C5D7}"/>
              </a:ext>
            </a:extLst>
          </p:cNvPr>
          <p:cNvSpPr txBox="1"/>
          <p:nvPr/>
        </p:nvSpPr>
        <p:spPr>
          <a:xfrm>
            <a:off x="539130" y="2567283"/>
            <a:ext cx="387667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Loading buffer + </a:t>
            </a:r>
            <a:r>
              <a:rPr lang="en-US" dirty="0" err="1">
                <a:latin typeface="Arial"/>
                <a:cs typeface="Arial"/>
              </a:rPr>
              <a:t>DharmaFECT</a:t>
            </a:r>
            <a:r>
              <a:rPr lang="en-US" dirty="0">
                <a:latin typeface="Arial"/>
                <a:cs typeface="Arial"/>
              </a:rPr>
              <a:t>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A1A5B854-D054-4BAE-A751-5BE7A72761CF}"/>
              </a:ext>
            </a:extLst>
          </p:cNvPr>
          <p:cNvSpPr txBox="1"/>
          <p:nvPr/>
        </p:nvSpPr>
        <p:spPr>
          <a:xfrm>
            <a:off x="526518" y="4305578"/>
            <a:ext cx="374958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Loading buffer + INTERFERin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94295" y="185849"/>
            <a:ext cx="20194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. Negative mod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B2B9794B-BA4D-4A4D-B6A5-F77F51B877A6}"/>
              </a:ext>
            </a:extLst>
          </p:cNvPr>
          <p:cNvSpPr txBox="1"/>
          <p:nvPr/>
        </p:nvSpPr>
        <p:spPr>
          <a:xfrm rot="16200000">
            <a:off x="-861972" y="4769855"/>
            <a:ext cx="2026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 Ion Count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CE060096-DF33-40AE-8DD4-708813237A6E}"/>
              </a:ext>
            </a:extLst>
          </p:cNvPr>
          <p:cNvSpPr txBox="1"/>
          <p:nvPr/>
        </p:nvSpPr>
        <p:spPr>
          <a:xfrm rot="16200000">
            <a:off x="-833703" y="2839789"/>
            <a:ext cx="2026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 Ion Count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EBFFE97D-86BB-4613-AAC6-C94D7C147CD6}"/>
              </a:ext>
            </a:extLst>
          </p:cNvPr>
          <p:cNvSpPr txBox="1"/>
          <p:nvPr/>
        </p:nvSpPr>
        <p:spPr>
          <a:xfrm rot="16200000">
            <a:off x="-845774" y="1032277"/>
            <a:ext cx="20265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 Ion Counts</a:t>
            </a:r>
          </a:p>
        </p:txBody>
      </p:sp>
    </p:spTree>
    <p:extLst>
      <p:ext uri="{BB962C8B-B14F-4D97-AF65-F5344CB8AC3E}">
        <p14:creationId xmlns:p14="http://schemas.microsoft.com/office/powerpoint/2010/main" val="2773722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7</TotalTime>
  <Words>79</Words>
  <Application>Microsoft Macintosh PowerPoint</Application>
  <PresentationFormat>Custom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 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ggert</dc:creator>
  <cp:lastModifiedBy>Riki Eggert</cp:lastModifiedBy>
  <cp:revision>91</cp:revision>
  <dcterms:created xsi:type="dcterms:W3CDTF">2019-01-29T16:52:04Z</dcterms:created>
  <dcterms:modified xsi:type="dcterms:W3CDTF">2019-04-30T13:17:06Z</dcterms:modified>
</cp:coreProperties>
</file>